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93" r:id="rId2"/>
    <p:sldId id="291" r:id="rId3"/>
    <p:sldId id="292" r:id="rId4"/>
    <p:sldId id="282" r:id="rId5"/>
    <p:sldId id="289" r:id="rId6"/>
    <p:sldId id="286" r:id="rId7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F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28" autoAdjust="0"/>
    <p:restoredTop sz="96247" autoAdjust="0"/>
  </p:normalViewPr>
  <p:slideViewPr>
    <p:cSldViewPr snapToGrid="0">
      <p:cViewPr varScale="1">
        <p:scale>
          <a:sx n="77" d="100"/>
          <a:sy n="77" d="100"/>
        </p:scale>
        <p:origin x="148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 Ahmed Elshazly" userId="92faafa7-b1de-4194-ac20-c5423e5d0806" providerId="ADAL" clId="{591B1513-E534-4A55-B858-A57CE2E401C3}"/>
    <pc:docChg chg="undo custSel addSld delSld modSld sldOrd">
      <pc:chgData name="Dr Ahmed Elshazly" userId="92faafa7-b1de-4194-ac20-c5423e5d0806" providerId="ADAL" clId="{591B1513-E534-4A55-B858-A57CE2E401C3}" dt="2026-04-29T10:25:05.526" v="3730" actId="1076"/>
      <pc:docMkLst>
        <pc:docMk/>
      </pc:docMkLst>
      <pc:sldChg chg="modSp mod">
        <pc:chgData name="Dr Ahmed Elshazly" userId="92faafa7-b1de-4194-ac20-c5423e5d0806" providerId="ADAL" clId="{591B1513-E534-4A55-B858-A57CE2E401C3}" dt="2026-04-29T10:25:05.526" v="3730" actId="1076"/>
        <pc:sldMkLst>
          <pc:docMk/>
          <pc:sldMk cId="1355461078" sldId="258"/>
        </pc:sldMkLst>
        <pc:spChg chg="mod">
          <ac:chgData name="Dr Ahmed Elshazly" userId="92faafa7-b1de-4194-ac20-c5423e5d0806" providerId="ADAL" clId="{591B1513-E534-4A55-B858-A57CE2E401C3}" dt="2026-04-29T10:25:05.526" v="3730" actId="1076"/>
          <ac:spMkLst>
            <pc:docMk/>
            <pc:sldMk cId="1355461078" sldId="258"/>
            <ac:spMk id="18" creationId="{BDA0FF7C-E9C1-E7DE-AC4A-9C1F1DA9F9E4}"/>
          </ac:spMkLst>
        </pc:spChg>
        <pc:spChg chg="mod">
          <ac:chgData name="Dr Ahmed Elshazly" userId="92faafa7-b1de-4194-ac20-c5423e5d0806" providerId="ADAL" clId="{591B1513-E534-4A55-B858-A57CE2E401C3}" dt="2026-04-29T10:24:43.361" v="3717" actId="1035"/>
          <ac:spMkLst>
            <pc:docMk/>
            <pc:sldMk cId="1355461078" sldId="258"/>
            <ac:spMk id="21" creationId="{BDA0FF7C-E9C1-E7DE-AC4A-9C1F1DA9F9E4}"/>
          </ac:spMkLst>
        </pc:spChg>
        <pc:spChg chg="mod">
          <ac:chgData name="Dr Ahmed Elshazly" userId="92faafa7-b1de-4194-ac20-c5423e5d0806" providerId="ADAL" clId="{591B1513-E534-4A55-B858-A57CE2E401C3}" dt="2026-04-29T10:19:04.901" v="3695" actId="1076"/>
          <ac:spMkLst>
            <pc:docMk/>
            <pc:sldMk cId="1355461078" sldId="258"/>
            <ac:spMk id="31" creationId="{BDA0FF7C-E9C1-E7DE-AC4A-9C1F1DA9F9E4}"/>
          </ac:spMkLst>
        </pc:spChg>
        <pc:spChg chg="mod">
          <ac:chgData name="Dr Ahmed Elshazly" userId="92faafa7-b1de-4194-ac20-c5423e5d0806" providerId="ADAL" clId="{591B1513-E534-4A55-B858-A57CE2E401C3}" dt="2026-04-29T10:24:43.361" v="3717" actId="1035"/>
          <ac:spMkLst>
            <pc:docMk/>
            <pc:sldMk cId="1355461078" sldId="258"/>
            <ac:spMk id="35" creationId="{27444453-551F-6313-CD1B-D5B90DFFB64B}"/>
          </ac:spMkLst>
        </pc:spChg>
        <pc:spChg chg="mod">
          <ac:chgData name="Dr Ahmed Elshazly" userId="92faafa7-b1de-4194-ac20-c5423e5d0806" providerId="ADAL" clId="{591B1513-E534-4A55-B858-A57CE2E401C3}" dt="2026-04-29T10:24:55.070" v="3727" actId="1035"/>
          <ac:spMkLst>
            <pc:docMk/>
            <pc:sldMk cId="1355461078" sldId="258"/>
            <ac:spMk id="37" creationId="{475E86C7-6CAA-5574-AFF4-58C68671844D}"/>
          </ac:spMkLst>
        </pc:spChg>
        <pc:spChg chg="mod">
          <ac:chgData name="Dr Ahmed Elshazly" userId="92faafa7-b1de-4194-ac20-c5423e5d0806" providerId="ADAL" clId="{591B1513-E534-4A55-B858-A57CE2E401C3}" dt="2026-04-29T10:24:46.256" v="3718" actId="1076"/>
          <ac:spMkLst>
            <pc:docMk/>
            <pc:sldMk cId="1355461078" sldId="258"/>
            <ac:spMk id="39" creationId="{35A69FD3-6B7F-BC6E-0D9F-B9BA275D34CD}"/>
          </ac:spMkLst>
        </pc:spChg>
        <pc:graphicFrameChg chg="mod">
          <ac:chgData name="Dr Ahmed Elshazly" userId="92faafa7-b1de-4194-ac20-c5423e5d0806" providerId="ADAL" clId="{591B1513-E534-4A55-B858-A57CE2E401C3}" dt="2026-04-29T10:24:23.512" v="3703" actId="1036"/>
          <ac:graphicFrameMkLst>
            <pc:docMk/>
            <pc:sldMk cId="1355461078" sldId="258"/>
            <ac:graphicFrameMk id="4" creationId="{5ADCF8B4-BA36-CCF0-AE71-655FBF59BA90}"/>
          </ac:graphicFrameMkLst>
        </pc:graphicFrameChg>
        <pc:graphicFrameChg chg="mod">
          <ac:chgData name="Dr Ahmed Elshazly" userId="92faafa7-b1de-4194-ac20-c5423e5d0806" providerId="ADAL" clId="{591B1513-E534-4A55-B858-A57CE2E401C3}" dt="2026-04-29T10:24:17.374" v="3698" actId="1076"/>
          <ac:graphicFrameMkLst>
            <pc:docMk/>
            <pc:sldMk cId="1355461078" sldId="258"/>
            <ac:graphicFrameMk id="5" creationId="{506E88E4-643A-74A5-3714-831C2923B213}"/>
          </ac:graphicFrameMkLst>
        </pc:graphicFrameChg>
        <pc:graphicFrameChg chg="mod">
          <ac:chgData name="Dr Ahmed Elshazly" userId="92faafa7-b1de-4194-ac20-c5423e5d0806" providerId="ADAL" clId="{591B1513-E534-4A55-B858-A57CE2E401C3}" dt="2026-04-29T10:24:43.361" v="3717" actId="1035"/>
          <ac:graphicFrameMkLst>
            <pc:docMk/>
            <pc:sldMk cId="1355461078" sldId="258"/>
            <ac:graphicFrameMk id="12" creationId="{4E069178-FDA2-D5E4-9A5F-5E0283678BBB}"/>
          </ac:graphicFrameMkLst>
        </pc:graphicFrameChg>
        <pc:graphicFrameChg chg="mod">
          <ac:chgData name="Dr Ahmed Elshazly" userId="92faafa7-b1de-4194-ac20-c5423e5d0806" providerId="ADAL" clId="{591B1513-E534-4A55-B858-A57CE2E401C3}" dt="2026-04-29T10:24:43.361" v="3717" actId="1035"/>
          <ac:graphicFrameMkLst>
            <pc:docMk/>
            <pc:sldMk cId="1355461078" sldId="258"/>
            <ac:graphicFrameMk id="16" creationId="{86BF069D-DB2D-576B-5C05-9D1AB7524D66}"/>
          </ac:graphicFrameMkLst>
        </pc:graphicFrameChg>
        <pc:picChg chg="mod">
          <ac:chgData name="Dr Ahmed Elshazly" userId="92faafa7-b1de-4194-ac20-c5423e5d0806" providerId="ADAL" clId="{591B1513-E534-4A55-B858-A57CE2E401C3}" dt="2026-04-29T10:24:43.361" v="3717" actId="1035"/>
          <ac:picMkLst>
            <pc:docMk/>
            <pc:sldMk cId="1355461078" sldId="258"/>
            <ac:picMk id="3" creationId="{B7CF42A8-84B9-99C6-8BAA-3A9BBB85E9CC}"/>
          </ac:picMkLst>
        </pc:picChg>
        <pc:picChg chg="mod">
          <ac:chgData name="Dr Ahmed Elshazly" userId="92faafa7-b1de-4194-ac20-c5423e5d0806" providerId="ADAL" clId="{591B1513-E534-4A55-B858-A57CE2E401C3}" dt="2026-04-29T10:25:03.613" v="3729" actId="1076"/>
          <ac:picMkLst>
            <pc:docMk/>
            <pc:sldMk cId="1355461078" sldId="258"/>
            <ac:picMk id="6" creationId="{7662DE2F-029D-C929-3520-817DE3318C30}"/>
          </ac:picMkLst>
        </pc:picChg>
        <pc:picChg chg="mod modCrop">
          <ac:chgData name="Dr Ahmed Elshazly" userId="92faafa7-b1de-4194-ac20-c5423e5d0806" providerId="ADAL" clId="{591B1513-E534-4A55-B858-A57CE2E401C3}" dt="2026-04-29T10:19:01.109" v="3694" actId="1076"/>
          <ac:picMkLst>
            <pc:docMk/>
            <pc:sldMk cId="1355461078" sldId="258"/>
            <ac:picMk id="9" creationId="{C1308A45-A047-A4DC-A9EF-0CEE2CD9418D}"/>
          </ac:picMkLst>
        </pc:picChg>
        <pc:picChg chg="mod">
          <ac:chgData name="Dr Ahmed Elshazly" userId="92faafa7-b1de-4194-ac20-c5423e5d0806" providerId="ADAL" clId="{591B1513-E534-4A55-B858-A57CE2E401C3}" dt="2026-04-29T10:24:57.095" v="3728" actId="1076"/>
          <ac:picMkLst>
            <pc:docMk/>
            <pc:sldMk cId="1355461078" sldId="258"/>
            <ac:picMk id="19" creationId="{DD2E9AE4-79F2-E23D-6F81-C8B4FB3072D0}"/>
          </ac:picMkLst>
        </pc:picChg>
        <pc:picChg chg="mod">
          <ac:chgData name="Dr Ahmed Elshazly" userId="92faafa7-b1de-4194-ac20-c5423e5d0806" providerId="ADAL" clId="{591B1513-E534-4A55-B858-A57CE2E401C3}" dt="2026-04-29T10:24:43.361" v="3717" actId="1035"/>
          <ac:picMkLst>
            <pc:docMk/>
            <pc:sldMk cId="1355461078" sldId="258"/>
            <ac:picMk id="32" creationId="{9EAABB34-2D86-5974-DA0D-79D9851619BB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4-08T00:22:13.381" v="3684"/>
        <pc:sldMkLst>
          <pc:docMk/>
          <pc:sldMk cId="122242903" sldId="290"/>
        </pc:sldMkLst>
        <pc:graphicFrameChg chg="add mod">
          <ac:chgData name="Dr Ahmed Elshazly" userId="92faafa7-b1de-4194-ac20-c5423e5d0806" providerId="ADAL" clId="{591B1513-E534-4A55-B858-A57CE2E401C3}" dt="2026-04-08T00:10:34.491" v="3679"/>
          <ac:graphicFrameMkLst>
            <pc:docMk/>
            <pc:sldMk cId="122242903" sldId="290"/>
            <ac:graphicFrameMk id="2" creationId="{3FBBA0DA-E008-3477-1D61-99CD44591146}"/>
          </ac:graphicFrameMkLst>
        </pc:graphicFrameChg>
        <pc:graphicFrameChg chg="add mod">
          <ac:chgData name="Dr Ahmed Elshazly" userId="92faafa7-b1de-4194-ac20-c5423e5d0806" providerId="ADAL" clId="{591B1513-E534-4A55-B858-A57CE2E401C3}" dt="2026-04-08T00:22:13.381" v="3684"/>
          <ac:graphicFrameMkLst>
            <pc:docMk/>
            <pc:sldMk cId="122242903" sldId="290"/>
            <ac:graphicFrameMk id="3" creationId="{E9D1A17F-6783-75D1-7241-940141BA48DF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image" Target="../media/image26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image" Target="../media/image3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0D55F2-C4D0-4585-B57D-E68318625765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26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575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B93C9E-D22D-4227-9AE5-4BB13CD6A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44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89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663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796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53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17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357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66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817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356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918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284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A4E82-583E-4B44-AC0C-7137CD5174E8}" type="datetimeFigureOut">
              <a:rPr lang="en-US" smtClean="0"/>
              <a:t>5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77700-B462-4E31-A45D-69E0409D8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11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emf"/><Relationship Id="rId9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12.png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11" Type="http://schemas.openxmlformats.org/officeDocument/2006/relationships/image" Target="../media/image14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1.emf"/><Relationship Id="rId4" Type="http://schemas.openxmlformats.org/officeDocument/2006/relationships/image" Target="../media/image13.png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33.png"/><Relationship Id="rId18" Type="http://schemas.openxmlformats.org/officeDocument/2006/relationships/image" Target="../media/image36.png"/><Relationship Id="rId3" Type="http://schemas.openxmlformats.org/officeDocument/2006/relationships/oleObject" Target="../embeddings/oleObject5.bin"/><Relationship Id="rId7" Type="http://schemas.openxmlformats.org/officeDocument/2006/relationships/image" Target="../media/image27.emf"/><Relationship Id="rId12" Type="http://schemas.openxmlformats.org/officeDocument/2006/relationships/image" Target="../media/image32.png"/><Relationship Id="rId17" Type="http://schemas.openxmlformats.org/officeDocument/2006/relationships/image" Target="../media/image35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30.emf"/><Relationship Id="rId20" Type="http://schemas.openxmlformats.org/officeDocument/2006/relationships/image" Target="../media/image38.png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29.emf"/><Relationship Id="rId5" Type="http://schemas.openxmlformats.org/officeDocument/2006/relationships/image" Target="../media/image31.png"/><Relationship Id="rId15" Type="http://schemas.openxmlformats.org/officeDocument/2006/relationships/oleObject" Target="../embeddings/oleObject9.bin"/><Relationship Id="rId10" Type="http://schemas.openxmlformats.org/officeDocument/2006/relationships/oleObject" Target="../embeddings/oleObject8.bin"/><Relationship Id="rId19" Type="http://schemas.openxmlformats.org/officeDocument/2006/relationships/image" Target="../media/image37.png"/><Relationship Id="rId4" Type="http://schemas.openxmlformats.org/officeDocument/2006/relationships/image" Target="../media/image26.emf"/><Relationship Id="rId9" Type="http://schemas.openxmlformats.org/officeDocument/2006/relationships/image" Target="../media/image28.emf"/><Relationship Id="rId14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3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F6569CF-26D5-3DE9-961F-874BD0DD9497}"/>
              </a:ext>
            </a:extLst>
          </p:cNvPr>
          <p:cNvGrpSpPr/>
          <p:nvPr/>
        </p:nvGrpSpPr>
        <p:grpSpPr>
          <a:xfrm>
            <a:off x="550117" y="809306"/>
            <a:ext cx="5560286" cy="2801020"/>
            <a:chOff x="-184785" y="-274600"/>
            <a:chExt cx="6513323" cy="3248635"/>
          </a:xfrm>
        </p:grpSpPr>
        <p:sp>
          <p:nvSpPr>
            <p:cNvPr id="5" name="Text Box 6">
              <a:extLst>
                <a:ext uri="{FF2B5EF4-FFF2-40B4-BE49-F238E27FC236}">
                  <a16:creationId xmlns:a16="http://schemas.microsoft.com/office/drawing/2014/main" id="{7F760092-0A91-8CA4-88E4-2614415FAECB}"/>
                </a:ext>
              </a:extLst>
            </p:cNvPr>
            <p:cNvSpPr txBox="1"/>
            <p:nvPr/>
          </p:nvSpPr>
          <p:spPr>
            <a:xfrm>
              <a:off x="-184785" y="-274600"/>
              <a:ext cx="369569" cy="28575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buNone/>
              </a:pPr>
              <a:r>
                <a:rPr lang="en-US" sz="12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" name="Text Box 6">
              <a:extLst>
                <a:ext uri="{FF2B5EF4-FFF2-40B4-BE49-F238E27FC236}">
                  <a16:creationId xmlns:a16="http://schemas.microsoft.com/office/drawing/2014/main" id="{885354C9-7E6A-428E-13DB-4204974DB954}"/>
                </a:ext>
              </a:extLst>
            </p:cNvPr>
            <p:cNvSpPr txBox="1"/>
            <p:nvPr/>
          </p:nvSpPr>
          <p:spPr>
            <a:xfrm>
              <a:off x="4075407" y="11150"/>
              <a:ext cx="369569" cy="28575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buNone/>
              </a:pPr>
              <a:r>
                <a:rPr lang="en-US" sz="12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7" name="Picture 6" descr="A close-up of a structure&#10;&#10;AI-generated content may be incorrect.">
              <a:extLst>
                <a:ext uri="{FF2B5EF4-FFF2-40B4-BE49-F238E27FC236}">
                  <a16:creationId xmlns:a16="http://schemas.microsoft.com/office/drawing/2014/main" id="{9A2EB2DE-62F8-687F-9A91-2A44BCEB0C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55" t="2435" r="23501" b="6488"/>
            <a:stretch>
              <a:fillRect/>
            </a:stretch>
          </p:blipFill>
          <p:spPr bwMode="auto">
            <a:xfrm>
              <a:off x="4220973" y="320277"/>
              <a:ext cx="2107565" cy="2113914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7BD8C8F-ECD6-92DE-1E85-025841D143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863" t="7951" r="15304" b="52187"/>
            <a:stretch>
              <a:fillRect/>
            </a:stretch>
          </p:blipFill>
          <p:spPr bwMode="auto">
            <a:xfrm>
              <a:off x="245212" y="11150"/>
              <a:ext cx="3668616" cy="296288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C0E35111-A936-6069-8DFE-C31899C6AF48}"/>
              </a:ext>
            </a:extLst>
          </p:cNvPr>
          <p:cNvSpPr txBox="1"/>
          <p:nvPr/>
        </p:nvSpPr>
        <p:spPr>
          <a:xfrm>
            <a:off x="515118" y="3888625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4AC442D-07AA-438E-A981-43008A8C1224}"/>
              </a:ext>
            </a:extLst>
          </p:cNvPr>
          <p:cNvSpPr txBox="1"/>
          <p:nvPr/>
        </p:nvSpPr>
        <p:spPr>
          <a:xfrm>
            <a:off x="184581" y="55176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E78E700-7799-4A01-9BC0-5413DCFA56BC}"/>
              </a:ext>
            </a:extLst>
          </p:cNvPr>
          <p:cNvGrpSpPr/>
          <p:nvPr/>
        </p:nvGrpSpPr>
        <p:grpSpPr>
          <a:xfrm>
            <a:off x="793509" y="3902483"/>
            <a:ext cx="5509840" cy="1959650"/>
            <a:chOff x="221826" y="-33056"/>
            <a:chExt cx="6303617" cy="2072316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63D98097-447C-4A04-9F98-3D900053B030}"/>
                </a:ext>
              </a:extLst>
            </p:cNvPr>
            <p:cNvGrpSpPr/>
            <p:nvPr/>
          </p:nvGrpSpPr>
          <p:grpSpPr>
            <a:xfrm>
              <a:off x="221826" y="-33056"/>
              <a:ext cx="4210100" cy="2072316"/>
              <a:chOff x="187272" y="-72426"/>
              <a:chExt cx="4213972" cy="2072713"/>
            </a:xfrm>
          </p:grpSpPr>
          <p:pic>
            <p:nvPicPr>
              <p:cNvPr id="27" name="Picture 26" descr="A structure of a molecule&#10;&#10;AI-generated content may be incorrect.">
                <a:extLst>
                  <a:ext uri="{FF2B5EF4-FFF2-40B4-BE49-F238E27FC236}">
                    <a16:creationId xmlns:a16="http://schemas.microsoft.com/office/drawing/2014/main" id="{53ED8D0E-8624-4AD3-A34A-8B508A5EDA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139" r="23077" b="11013"/>
              <a:stretch>
                <a:fillRect/>
              </a:stretch>
            </p:blipFill>
            <p:spPr bwMode="auto">
              <a:xfrm>
                <a:off x="187272" y="8313"/>
                <a:ext cx="2001366" cy="1991974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28" name="Picture 27" descr="A structure of a molecule&#10;&#10;AI-generated content may be incorrect.">
                <a:extLst>
                  <a:ext uri="{FF2B5EF4-FFF2-40B4-BE49-F238E27FC236}">
                    <a16:creationId xmlns:a16="http://schemas.microsoft.com/office/drawing/2014/main" id="{6A0F32D3-BD29-483C-97E0-2AA30ECE03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140" t="1" r="20044" b="6466"/>
              <a:stretch>
                <a:fillRect/>
              </a:stretch>
            </p:blipFill>
            <p:spPr bwMode="auto">
              <a:xfrm>
                <a:off x="2271525" y="-72426"/>
                <a:ext cx="2129719" cy="2072713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29" name="Text Box 6">
                <a:extLst>
                  <a:ext uri="{FF2B5EF4-FFF2-40B4-BE49-F238E27FC236}">
                    <a16:creationId xmlns:a16="http://schemas.microsoft.com/office/drawing/2014/main" id="{F9F3EE15-C40D-4691-A636-F2B71718F408}"/>
                  </a:ext>
                </a:extLst>
              </p:cNvPr>
              <p:cNvSpPr txBox="1"/>
              <p:nvPr/>
            </p:nvSpPr>
            <p:spPr>
              <a:xfrm>
                <a:off x="245726" y="16625"/>
                <a:ext cx="567236" cy="252688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200" b="1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C1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0" name="Text Box 6">
                <a:extLst>
                  <a:ext uri="{FF2B5EF4-FFF2-40B4-BE49-F238E27FC236}">
                    <a16:creationId xmlns:a16="http://schemas.microsoft.com/office/drawing/2014/main" id="{CDB7B21C-9B84-41D8-87BF-0E49C5D672C6}"/>
                  </a:ext>
                </a:extLst>
              </p:cNvPr>
              <p:cNvSpPr txBox="1"/>
              <p:nvPr/>
            </p:nvSpPr>
            <p:spPr>
              <a:xfrm>
                <a:off x="2222791" y="-16437"/>
                <a:ext cx="567236" cy="285750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200" b="1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C2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A2CEA06-089F-4AAD-9AB8-65BA59FF58F8}"/>
                </a:ext>
              </a:extLst>
            </p:cNvPr>
            <p:cNvGrpSpPr/>
            <p:nvPr/>
          </p:nvGrpSpPr>
          <p:grpSpPr>
            <a:xfrm>
              <a:off x="4412961" y="-27"/>
              <a:ext cx="2112482" cy="2039287"/>
              <a:chOff x="4412961" y="-2939997"/>
              <a:chExt cx="2112482" cy="2039287"/>
            </a:xfrm>
          </p:grpSpPr>
          <p:pic>
            <p:nvPicPr>
              <p:cNvPr id="25" name="Picture 24" descr="A structure of a protein&#10;&#10;AI-generated content may be incorrect.">
                <a:extLst>
                  <a:ext uri="{FF2B5EF4-FFF2-40B4-BE49-F238E27FC236}">
                    <a16:creationId xmlns:a16="http://schemas.microsoft.com/office/drawing/2014/main" id="{FB387550-D0AD-4AE8-8B4C-CDFDFFFF83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796" r="10614" b="5461"/>
              <a:stretch>
                <a:fillRect/>
              </a:stretch>
            </p:blipFill>
            <p:spPr bwMode="auto">
              <a:xfrm>
                <a:off x="4412961" y="-2917047"/>
                <a:ext cx="2112482" cy="2016337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26" name="Text Box 6">
                <a:extLst>
                  <a:ext uri="{FF2B5EF4-FFF2-40B4-BE49-F238E27FC236}">
                    <a16:creationId xmlns:a16="http://schemas.microsoft.com/office/drawing/2014/main" id="{8A681D66-DF67-4E59-BE2C-6DB809F16F12}"/>
                  </a:ext>
                </a:extLst>
              </p:cNvPr>
              <p:cNvSpPr txBox="1"/>
              <p:nvPr/>
            </p:nvSpPr>
            <p:spPr>
              <a:xfrm>
                <a:off x="4431926" y="-2939997"/>
                <a:ext cx="574929" cy="285695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200" b="1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C3</a:t>
                </a:r>
                <a:endPara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927C3550-CC53-4AB1-A7EA-AA41983922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43017"/>
              </p:ext>
            </p:extLst>
          </p:nvPr>
        </p:nvGraphicFramePr>
        <p:xfrm>
          <a:off x="0" y="6616060"/>
          <a:ext cx="1130051" cy="161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10" r:id="rId8" imgW="2017120" imgH="2887715" progId="Prism10.Document">
                  <p:embed/>
                </p:oleObj>
              </mc:Choice>
              <mc:Fallback>
                <p:oleObj name="Prism 10" r:id="rId8" imgW="2017120" imgH="2887715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927C3550-CC53-4AB1-A7EA-AA41983922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0" y="6616060"/>
                        <a:ext cx="1130051" cy="161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3">
            <a:extLst>
              <a:ext uri="{FF2B5EF4-FFF2-40B4-BE49-F238E27FC236}">
                <a16:creationId xmlns:a16="http://schemas.microsoft.com/office/drawing/2014/main" id="{6F455C0C-D28F-431D-F3CA-3AB494959EC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27727" y="6381560"/>
            <a:ext cx="3116972" cy="18517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92B3B9D-76EC-24BB-8C22-924E026F670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82380" y="6378449"/>
            <a:ext cx="2095786" cy="18548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4FB5C93-B0E9-BBA9-039D-A43A01F29529}"/>
              </a:ext>
            </a:extLst>
          </p:cNvPr>
          <p:cNvSpPr txBox="1"/>
          <p:nvPr/>
        </p:nvSpPr>
        <p:spPr>
          <a:xfrm>
            <a:off x="284278" y="6177358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0AD9851-DE44-7A63-69B0-7919ECDA079B}"/>
              </a:ext>
            </a:extLst>
          </p:cNvPr>
          <p:cNvSpPr txBox="1"/>
          <p:nvPr/>
        </p:nvSpPr>
        <p:spPr>
          <a:xfrm>
            <a:off x="4861105" y="6440187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9068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21FA25A-823E-1A29-8DBC-3027E33556A3}"/>
              </a:ext>
            </a:extLst>
          </p:cNvPr>
          <p:cNvSpPr txBox="1"/>
          <p:nvPr/>
        </p:nvSpPr>
        <p:spPr>
          <a:xfrm>
            <a:off x="184581" y="55176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CA9863-90CD-3F82-D359-DF4BAE7792DF}"/>
              </a:ext>
            </a:extLst>
          </p:cNvPr>
          <p:cNvSpPr txBox="1"/>
          <p:nvPr/>
        </p:nvSpPr>
        <p:spPr>
          <a:xfrm>
            <a:off x="124201" y="407901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6B78340-A79A-408F-EE56-00D0399F35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5785" y="4501342"/>
            <a:ext cx="5174905" cy="254211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7625C89-4A2C-145D-4CDD-1ACBAD2FD4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3057" y="6915616"/>
            <a:ext cx="5702474" cy="2173208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FE351C9-AF22-86F8-140E-425B9E47F0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4371285"/>
              </p:ext>
            </p:extLst>
          </p:nvPr>
        </p:nvGraphicFramePr>
        <p:xfrm>
          <a:off x="2459876" y="2481944"/>
          <a:ext cx="1314418" cy="19930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2" name="Prism 10" r:id="rId5" imgW="2219877" imgH="3364919" progId="Prism10.Document">
                  <p:embed/>
                </p:oleObj>
              </mc:Choice>
              <mc:Fallback>
                <p:oleObj name="Prism 10" r:id="rId5" imgW="2219877" imgH="3364919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FE351C9-AF22-86F8-140E-425B9E47F0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59876" y="2481944"/>
                        <a:ext cx="1314418" cy="19930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CBA6D8B6-F222-420F-A621-05DE9334BD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942547"/>
              </p:ext>
            </p:extLst>
          </p:nvPr>
        </p:nvGraphicFramePr>
        <p:xfrm>
          <a:off x="5514464" y="2440891"/>
          <a:ext cx="1314418" cy="21112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3" name="Prism 10" r:id="rId7" imgW="2219877" imgH="3563004" progId="Prism10.Document">
                  <p:embed/>
                </p:oleObj>
              </mc:Choice>
              <mc:Fallback>
                <p:oleObj name="Prism 10" r:id="rId7" imgW="2219877" imgH="3563004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CBA6D8B6-F222-420F-A621-05DE9334BD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14464" y="2440891"/>
                        <a:ext cx="1314418" cy="21112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734567D1-44E2-D56B-ADB5-3CA3338EE2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0499123"/>
              </p:ext>
            </p:extLst>
          </p:nvPr>
        </p:nvGraphicFramePr>
        <p:xfrm>
          <a:off x="4022420" y="2517968"/>
          <a:ext cx="1243918" cy="20007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4" name="Prism 10" r:id="rId9" imgW="2112916" imgH="3396973" progId="Prism10.Document">
                  <p:embed/>
                </p:oleObj>
              </mc:Choice>
              <mc:Fallback>
                <p:oleObj name="Prism 10" r:id="rId9" imgW="2112916" imgH="3396973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734567D1-44E2-D56B-ADB5-3CA3338EE2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22420" y="2517968"/>
                        <a:ext cx="1243918" cy="20007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B4DDE042-5305-385E-6B08-A0C27656C1D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4201" y="333723"/>
            <a:ext cx="1261584" cy="429644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5C9C2F2-609E-922B-E704-8659E2AF912D}"/>
              </a:ext>
            </a:extLst>
          </p:cNvPr>
          <p:cNvSpPr txBox="1"/>
          <p:nvPr/>
        </p:nvSpPr>
        <p:spPr>
          <a:xfrm>
            <a:off x="1811932" y="2899022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4121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FA83707-4A78-E3EF-13A9-44405C2B37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0764" y="2885675"/>
            <a:ext cx="2027663" cy="166044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10BC710-0B1E-91F9-DE61-628E0E54C2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698" y="3900484"/>
            <a:ext cx="2054530" cy="201476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64685DD-130D-B715-5CB3-0C17C858E6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23825" y="4992884"/>
            <a:ext cx="1560711" cy="14692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5D5A67A-3546-9E5E-DCEA-0FD5E02772DB}"/>
              </a:ext>
            </a:extLst>
          </p:cNvPr>
          <p:cNvSpPr txBox="1"/>
          <p:nvPr/>
        </p:nvSpPr>
        <p:spPr>
          <a:xfrm>
            <a:off x="70839" y="112980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FB69C66-5884-DF31-C4DA-8425C16D62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2246" y="6986218"/>
            <a:ext cx="2198044" cy="19037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4DF567-D6C6-6063-31A4-367DBB8B7B2F}"/>
              </a:ext>
            </a:extLst>
          </p:cNvPr>
          <p:cNvSpPr txBox="1"/>
          <p:nvPr/>
        </p:nvSpPr>
        <p:spPr>
          <a:xfrm>
            <a:off x="152481" y="620992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8DE3328-7787-46F1-A5B1-B144453548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8529" y="6837779"/>
            <a:ext cx="1610589" cy="20493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2B2E6BA-D615-92A5-AFF1-19F9C8FABB8C}"/>
              </a:ext>
            </a:extLst>
          </p:cNvPr>
          <p:cNvSpPr txBox="1"/>
          <p:nvPr/>
        </p:nvSpPr>
        <p:spPr>
          <a:xfrm>
            <a:off x="2429229" y="731784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1BA0C4E-F4A4-BD6E-1031-C516027AF186}"/>
              </a:ext>
            </a:extLst>
          </p:cNvPr>
          <p:cNvSpPr txBox="1"/>
          <p:nvPr/>
        </p:nvSpPr>
        <p:spPr>
          <a:xfrm>
            <a:off x="4781293" y="468955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E4D3B1-7E60-3937-B7BB-E7521E08C4F9}"/>
              </a:ext>
            </a:extLst>
          </p:cNvPr>
          <p:cNvSpPr txBox="1"/>
          <p:nvPr/>
        </p:nvSpPr>
        <p:spPr>
          <a:xfrm>
            <a:off x="232773" y="3917214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8B97050-1815-4DB3-0D61-7CAF1CE8FF50}"/>
              </a:ext>
            </a:extLst>
          </p:cNvPr>
          <p:cNvSpPr txBox="1"/>
          <p:nvPr/>
        </p:nvSpPr>
        <p:spPr>
          <a:xfrm>
            <a:off x="2374409" y="3272177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B6A5E90-C24A-50C1-FCF8-BD429E59D8F9}"/>
              </a:ext>
            </a:extLst>
          </p:cNvPr>
          <p:cNvSpPr txBox="1"/>
          <p:nvPr/>
        </p:nvSpPr>
        <p:spPr>
          <a:xfrm>
            <a:off x="3028756" y="4866095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596BE0D-DE9B-11FA-CB8C-5F24D6E49D76}"/>
              </a:ext>
            </a:extLst>
          </p:cNvPr>
          <p:cNvSpPr txBox="1"/>
          <p:nvPr/>
        </p:nvSpPr>
        <p:spPr>
          <a:xfrm>
            <a:off x="347655" y="6498665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07B508-1EBB-3461-8609-896A96CE638F}"/>
              </a:ext>
            </a:extLst>
          </p:cNvPr>
          <p:cNvSpPr txBox="1"/>
          <p:nvPr/>
        </p:nvSpPr>
        <p:spPr>
          <a:xfrm>
            <a:off x="3289297" y="6908907"/>
            <a:ext cx="22976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73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0573AAA-D3F6-9B36-83D4-B7F7212A437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75714" y="403344"/>
            <a:ext cx="2149513" cy="385429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A3C7160-C77B-9D1B-17FE-E9C931788BA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580" y="735786"/>
            <a:ext cx="2054530" cy="253639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24954855-03FA-023D-B070-802AFB18F2E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58050" y="491885"/>
            <a:ext cx="2496725" cy="2372634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C54546A-94EF-46CE-81AA-BAD4538A0E3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84536" y="4642860"/>
            <a:ext cx="2496725" cy="2068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8032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2EA0FE-30C6-6D57-A938-BF74E4B50B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2340999-30D8-48D3-8279-9614339A30E5}"/>
              </a:ext>
            </a:extLst>
          </p:cNvPr>
          <p:cNvSpPr txBox="1"/>
          <p:nvPr/>
        </p:nvSpPr>
        <p:spPr>
          <a:xfrm>
            <a:off x="125190" y="87517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C147B53-780B-0EB8-9A71-C33D2ACCFD80}"/>
              </a:ext>
            </a:extLst>
          </p:cNvPr>
          <p:cNvSpPr txBox="1"/>
          <p:nvPr/>
        </p:nvSpPr>
        <p:spPr>
          <a:xfrm>
            <a:off x="401982" y="1759751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E2A6927-1422-EEE8-6D06-580FFC731C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2017" y="1408127"/>
            <a:ext cx="2679722" cy="3163873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C9663B77-3187-BDAF-0A11-3D3D010775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261" y="2322316"/>
            <a:ext cx="2566511" cy="212944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562F5CC-D8C2-B125-DCA2-4CC85549B638}"/>
              </a:ext>
            </a:extLst>
          </p:cNvPr>
          <p:cNvSpPr txBox="1"/>
          <p:nvPr/>
        </p:nvSpPr>
        <p:spPr>
          <a:xfrm>
            <a:off x="4079635" y="1759750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843469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BDA0FF7C-E9C1-E7DE-AC4A-9C1F1DA9F9E4}"/>
              </a:ext>
            </a:extLst>
          </p:cNvPr>
          <p:cNvSpPr txBox="1"/>
          <p:nvPr/>
        </p:nvSpPr>
        <p:spPr>
          <a:xfrm>
            <a:off x="53232" y="6907489"/>
            <a:ext cx="27924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43662FAD-2A0C-4623-8D23-7E801438A125}"/>
              </a:ext>
            </a:extLst>
          </p:cNvPr>
          <p:cNvGrpSpPr/>
          <p:nvPr/>
        </p:nvGrpSpPr>
        <p:grpSpPr>
          <a:xfrm>
            <a:off x="196861" y="482637"/>
            <a:ext cx="922593" cy="2280709"/>
            <a:chOff x="-211006" y="-6180566"/>
            <a:chExt cx="922593" cy="2280709"/>
          </a:xfrm>
        </p:grpSpPr>
        <p:sp>
          <p:nvSpPr>
            <p:cNvPr id="48" name="TextBox 47"/>
            <p:cNvSpPr txBox="1"/>
            <p:nvPr/>
          </p:nvSpPr>
          <p:spPr>
            <a:xfrm>
              <a:off x="481822" y="-6180566"/>
              <a:ext cx="229765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738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DA0FF7C-E9C1-E7DE-AC4A-9C1F1DA9F9E4}"/>
                </a:ext>
              </a:extLst>
            </p:cNvPr>
            <p:cNvSpPr txBox="1"/>
            <p:nvPr/>
          </p:nvSpPr>
          <p:spPr>
            <a:xfrm>
              <a:off x="-211006" y="-4162686"/>
              <a:ext cx="287258" cy="2628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8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BDA0FF7C-E9C1-E7DE-AC4A-9C1F1DA9F9E4}"/>
              </a:ext>
            </a:extLst>
          </p:cNvPr>
          <p:cNvSpPr txBox="1"/>
          <p:nvPr/>
        </p:nvSpPr>
        <p:spPr>
          <a:xfrm>
            <a:off x="53232" y="4661939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-44756" y="4276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4C2476B2-C0FD-44CC-9768-CB322D4C828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37948" y="745466"/>
          <a:ext cx="1230363" cy="1771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6" name="Prism 10" r:id="rId3" imgW="2017120" imgH="2904642" progId="Prism10.Document">
                  <p:embed/>
                </p:oleObj>
              </mc:Choice>
              <mc:Fallback>
                <p:oleObj name="Prism 10" r:id="rId3" imgW="2017120" imgH="2904642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4C2476B2-C0FD-44CC-9768-CB322D4C82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37948" y="745466"/>
                        <a:ext cx="1230363" cy="1771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3ED62415-52E5-7BC0-752A-6894FB6EC9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339" y="466395"/>
            <a:ext cx="3847249" cy="1934616"/>
          </a:xfrm>
          <a:prstGeom prst="rect">
            <a:avLst/>
          </a:prstGeom>
        </p:spPr>
      </p:pic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690A384-BA80-5DD2-4240-5F717BFFFD8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59515" y="7013575"/>
          <a:ext cx="2305050" cy="1927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7" name="Prism 10" r:id="rId6" imgW="4527986" imgH="3785579" progId="Prism10.Document">
                  <p:embed/>
                </p:oleObj>
              </mc:Choice>
              <mc:Fallback>
                <p:oleObj name="Prism 10" r:id="rId6" imgW="4527986" imgH="3785579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D690A384-BA80-5DD2-4240-5F717BFFFD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59515" y="7013575"/>
                        <a:ext cx="2305050" cy="1927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2A88811-6485-F62F-72A6-575342EC6A9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41755" y="7005637"/>
          <a:ext cx="2319337" cy="1935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8" name="Prism 10" r:id="rId8" imgW="4546353" imgH="3785579" progId="Prism10.Document">
                  <p:embed/>
                </p:oleObj>
              </mc:Choice>
              <mc:Fallback>
                <p:oleObj name="Prism 10" r:id="rId8" imgW="4546353" imgH="3785579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2A88811-6485-F62F-72A6-575342EC6A9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41755" y="7005637"/>
                        <a:ext cx="2319337" cy="19351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CBE17C1-9A6E-4FAA-5594-F202EFEA0D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127000" y="4883150"/>
          <a:ext cx="2306638" cy="1922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9" name="Prism 10" r:id="rId10" imgW="4527986" imgH="3776575" progId="Prism10.Document">
                  <p:embed/>
                </p:oleObj>
              </mc:Choice>
              <mc:Fallback>
                <p:oleObj name="Prism 10" r:id="rId10" imgW="4527986" imgH="3776575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0CBE17C1-9A6E-4FAA-5594-F202EFEA0D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-127000" y="4883150"/>
                        <a:ext cx="2306638" cy="1922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Picture 17">
            <a:extLst>
              <a:ext uri="{FF2B5EF4-FFF2-40B4-BE49-F238E27FC236}">
                <a16:creationId xmlns:a16="http://schemas.microsoft.com/office/drawing/2014/main" id="{38D2C09E-51F6-9E5A-2233-A54E68148E1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79569" y="2502594"/>
            <a:ext cx="3439485" cy="191948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79D5596-2032-17EF-83E2-708AD26E2F7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4546" y="2797465"/>
            <a:ext cx="2319338" cy="154972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26623407-4B67-CB87-D4B0-A8987084F015}"/>
              </a:ext>
            </a:extLst>
          </p:cNvPr>
          <p:cNvSpPr txBox="1"/>
          <p:nvPr/>
        </p:nvSpPr>
        <p:spPr>
          <a:xfrm>
            <a:off x="2726273" y="2534636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DC194B8-08F7-BA33-D54C-BCA227B0868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41867" y="4958446"/>
            <a:ext cx="1539970" cy="1924963"/>
          </a:xfrm>
          <a:prstGeom prst="rect">
            <a:avLst/>
          </a:prstGeom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943F52C-424A-7961-417C-075F76B61D9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31366" y="4881491"/>
          <a:ext cx="2319338" cy="1941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0" name="Prism 10" r:id="rId15" imgW="4546353" imgH="3797824" progId="Prism10.Document">
                  <p:embed/>
                </p:oleObj>
              </mc:Choice>
              <mc:Fallback>
                <p:oleObj name="Prism 10" r:id="rId15" imgW="4546353" imgH="3797824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8943F52C-424A-7961-417C-075F76B61D9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1366" y="4881491"/>
                        <a:ext cx="2319338" cy="19415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3" name="Picture 22">
            <a:extLst>
              <a:ext uri="{FF2B5EF4-FFF2-40B4-BE49-F238E27FC236}">
                <a16:creationId xmlns:a16="http://schemas.microsoft.com/office/drawing/2014/main" id="{50801758-2135-ECEB-87DE-BB4A2EBC690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308112" y="3402826"/>
            <a:ext cx="545125" cy="167957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95B4089-4505-76BB-899F-F380B31AD94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98326" y="4908443"/>
            <a:ext cx="1539970" cy="195007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EAD73B8-FD89-A100-A0B4-33E200D9999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031119" y="7072766"/>
            <a:ext cx="1487133" cy="186803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DF35D23-37C3-C69E-9562-31F07EFD8E8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342496" y="7076439"/>
            <a:ext cx="1487133" cy="1871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44370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2EA0FE-30C6-6D57-A938-BF74E4B50B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2340999-30D8-48D3-8279-9614339A30E5}"/>
              </a:ext>
            </a:extLst>
          </p:cNvPr>
          <p:cNvSpPr txBox="1"/>
          <p:nvPr/>
        </p:nvSpPr>
        <p:spPr>
          <a:xfrm>
            <a:off x="219835" y="114813"/>
            <a:ext cx="3363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E11535B-22AB-F69D-6B4D-29D0FD1F24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2270908"/>
              </p:ext>
            </p:extLst>
          </p:nvPr>
        </p:nvGraphicFramePr>
        <p:xfrm>
          <a:off x="322263" y="1522413"/>
          <a:ext cx="3117850" cy="2128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0" name="Prism 10" r:id="rId3" imgW="4520423" imgH="3089041" progId="Prism10.Document">
                  <p:embed/>
                </p:oleObj>
              </mc:Choice>
              <mc:Fallback>
                <p:oleObj name="Prism 10" r:id="rId3" imgW="4520423" imgH="3089041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1E11535B-22AB-F69D-6B4D-29D0FD1F24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2263" y="1522413"/>
                        <a:ext cx="3117850" cy="2128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34D1C930-E091-1D5E-0487-EC9F13A712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8681" y="1653539"/>
            <a:ext cx="2315855" cy="157531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F67D511-74DE-ADCF-15AA-EADEBDB5C22A}"/>
              </a:ext>
            </a:extLst>
          </p:cNvPr>
          <p:cNvSpPr txBox="1"/>
          <p:nvPr/>
        </p:nvSpPr>
        <p:spPr>
          <a:xfrm>
            <a:off x="4035052" y="1522125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C147B53-780B-0EB8-9A71-C33D2ACCFD80}"/>
              </a:ext>
            </a:extLst>
          </p:cNvPr>
          <p:cNvSpPr txBox="1"/>
          <p:nvPr/>
        </p:nvSpPr>
        <p:spPr>
          <a:xfrm>
            <a:off x="219835" y="1390711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F6B3CD4-95EE-BEC4-D602-03F9A48FFF1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35052" y="4030326"/>
            <a:ext cx="2066458" cy="3207842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B99691F-1809-4CFA-AC6A-7946C85414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7628051"/>
              </p:ext>
            </p:extLst>
          </p:nvPr>
        </p:nvGraphicFramePr>
        <p:xfrm>
          <a:off x="363464" y="4400552"/>
          <a:ext cx="3117849" cy="2147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1" name="Prism 10" r:id="rId7" imgW="4363404" imgH="3009807" progId="Prism10.Document">
                  <p:embed/>
                </p:oleObj>
              </mc:Choice>
              <mc:Fallback>
                <p:oleObj name="Prism 10" r:id="rId7" imgW="4363404" imgH="3009807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B99691F-1809-4CFA-AC6A-7946C85414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3464" y="4400552"/>
                        <a:ext cx="3117849" cy="2147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3F4B32E5-312B-4495-836A-44B085E75F17}"/>
              </a:ext>
            </a:extLst>
          </p:cNvPr>
          <p:cNvSpPr txBox="1"/>
          <p:nvPr/>
        </p:nvSpPr>
        <p:spPr>
          <a:xfrm>
            <a:off x="363464" y="4133429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6A816E-E6CA-470B-A7E0-9A6A7DA55661}"/>
              </a:ext>
            </a:extLst>
          </p:cNvPr>
          <p:cNvSpPr txBox="1"/>
          <p:nvPr/>
        </p:nvSpPr>
        <p:spPr>
          <a:xfrm>
            <a:off x="3909359" y="4133428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451331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740</TotalTime>
  <Words>47</Words>
  <Application>Microsoft Office PowerPoint</Application>
  <PresentationFormat>On-screen Show (4:3)</PresentationFormat>
  <Paragraphs>35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1</dc:creator>
  <cp:lastModifiedBy>Ashish Rawat1</cp:lastModifiedBy>
  <cp:revision>642</cp:revision>
  <cp:lastPrinted>2025-06-17T15:21:34Z</cp:lastPrinted>
  <dcterms:created xsi:type="dcterms:W3CDTF">2018-06-07T17:52:23Z</dcterms:created>
  <dcterms:modified xsi:type="dcterms:W3CDTF">2026-05-07T04:21:58Z</dcterms:modified>
</cp:coreProperties>
</file>